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81706-893A-4692-9F2F-C31D3B706E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A9427-B838-49ED-B4CB-63B7FF3E98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4D625-DF32-4D7B-A9F6-4F89CBE8C4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F8760-F698-4198-965B-86617BB1BA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FA3BF-15A6-4287-BB9C-AF75E7B2AC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EDA47-3E13-4985-BED3-5231DE0A7A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59B31-0B86-4963-B681-53D06A532C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E9ED3-54DC-4E22-9594-0F3762AE1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A36A1-9510-4F6F-8E17-856AD6B771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1BEC3-316C-4A68-A9BE-41C325B705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C305E6-2BD8-4325-A57E-E50395AF2A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AE812-ADF6-4332-A9FF-EB44857C29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09CF08-91DC-45B4-AED7-EEDB042ED5DC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7"/>
          <p:cNvGrpSpPr/>
          <p:nvPr/>
        </p:nvGrpSpPr>
        <p:grpSpPr>
          <a:xfrm>
            <a:off x="2560680" y="520560"/>
            <a:ext cx="7072200" cy="5785560"/>
            <a:chOff x="2560680" y="520560"/>
            <a:chExt cx="7072200" cy="5785560"/>
          </a:xfrm>
        </p:grpSpPr>
        <p:sp>
          <p:nvSpPr>
            <p:cNvPr id="42" name="Rettangolo 3"/>
            <p:cNvSpPr/>
            <p:nvPr/>
          </p:nvSpPr>
          <p:spPr>
            <a:xfrm>
              <a:off x="2563560" y="520560"/>
              <a:ext cx="7061400" cy="5785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BIOLOGICAL DOMAIN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ge </a:t>
              </a:r>
              <a:r>
                <a:rPr b="0" lang="en-GB" sz="1100" spc="-1" strike="noStrike" u="sng">
                  <a:solidFill>
                    <a:srgbClr val="000000"/>
                  </a:solidFill>
                  <a:uFillTx/>
                  <a:latin typeface="Arial"/>
                  <a:ea typeface="MS Mincho"/>
                </a:rPr>
                <a:t>&gt;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75 year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take ≥ 5 medication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CIRS &gt; 3 and/or CIRS severity &gt;3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↑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frailty (Edmonton Frail Scale &gt; 5)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↓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mobilization (Barthel&lt;60)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 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SOCIOECONOMIC DOMAIN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iving alone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come &lt; 1000 €/month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Unemployment/precarious work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Dependent/disabled family member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eed for a caregiver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 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EHAVIORAL DOMAIN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adequate adherence to medication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ctive smoking of at least 4 cigarettes/day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lcohol (&gt;3 Alcohol Units/day) and/or drug abuse (current or past)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appropriate diet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Cognitive impairment (Short Blessed Test &gt; 9)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 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ENVIRONMENTAL DOMA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stitutionalization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Difficult access to healthcare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Presence of home architectural barrier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Occupational exposure to toxin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Air pollution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 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CULTURAL DOMA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Schooling &lt; 8 year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Insufficient access to information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ack of adherence to health screening program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Language barriers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Perceived discrimination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yes☐ 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	</a:t>
              </a: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no☐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Connettore diritto 2"/>
            <p:cNvSpPr/>
            <p:nvPr/>
          </p:nvSpPr>
          <p:spPr>
            <a:xfrm>
              <a:off x="2565360" y="1703160"/>
              <a:ext cx="7061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Connettore diritto 4"/>
            <p:cNvSpPr/>
            <p:nvPr/>
          </p:nvSpPr>
          <p:spPr>
            <a:xfrm>
              <a:off x="2562120" y="2852640"/>
              <a:ext cx="7061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Connettore diritto 5"/>
            <p:cNvSpPr/>
            <p:nvPr/>
          </p:nvSpPr>
          <p:spPr>
            <a:xfrm>
              <a:off x="2560680" y="4021200"/>
              <a:ext cx="7061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Connettore diritto 6"/>
            <p:cNvSpPr/>
            <p:nvPr/>
          </p:nvSpPr>
          <p:spPr>
            <a:xfrm>
              <a:off x="2571480" y="5189760"/>
              <a:ext cx="70614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13T15:33:17Z</dcterms:created>
  <dc:creator>Pietro Formagnana</dc:creator>
  <dc:description/>
  <dc:language>en-US</dc:language>
  <cp:lastModifiedBy>Marco Vincenzo Lenti</cp:lastModifiedBy>
  <dcterms:modified xsi:type="dcterms:W3CDTF">2019-09-17T06:31:15Z</dcterms:modified>
  <cp:revision>28</cp:revision>
  <dc:subject/>
  <dc:title>Presentazione standard di PowerPoint</dc:title>
</cp:coreProperties>
</file>